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32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902138A1-8859-C301-5FBE-CE9761AFB1F8}"/>
              </a:ext>
            </a:extLst>
          </p:cNvPr>
          <p:cNvGraphicFramePr>
            <a:graphicFrameLocks noGrp="1"/>
          </p:cNvGraphicFramePr>
          <p:nvPr/>
        </p:nvGraphicFramePr>
        <p:xfrm>
          <a:off x="2009974" y="1335339"/>
          <a:ext cx="2804022" cy="5275084"/>
        </p:xfrm>
        <a:graphic>
          <a:graphicData uri="http://schemas.openxmlformats.org/drawingml/2006/table">
            <a:tbl>
              <a:tblPr firstRow="1" bandRow="1"/>
              <a:tblGrid>
                <a:gridCol w="1946534">
                  <a:extLst>
                    <a:ext uri="{9D8B030D-6E8A-4147-A177-3AD203B41FA5}">
                      <a16:colId xmlns:a16="http://schemas.microsoft.com/office/drawing/2014/main" val="2436836182"/>
                    </a:ext>
                  </a:extLst>
                </a:gridCol>
                <a:gridCol w="857488">
                  <a:extLst>
                    <a:ext uri="{9D8B030D-6E8A-4147-A177-3AD203B41FA5}">
                      <a16:colId xmlns:a16="http://schemas.microsoft.com/office/drawing/2014/main" val="91263939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 = 21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kern="1200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 (%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15017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riv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380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GFR3 S249C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 (52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55444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GFR3::TACC3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 (24)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8744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GFR3 Y373C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(14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61802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GFR2::FAM83H-AS1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87349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GFR4 D276N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93694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mor</a:t>
                      </a:r>
                      <a:r>
                        <a:rPr lang="fr-FR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9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calization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4376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adde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(57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6641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pper urothelial tract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 (33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00573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adder and upper urothelial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 (10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399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00371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dafitinib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(62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13863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migatinib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(14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4262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utibatinib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(14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6471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utibatinib (previous erdafitinib)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2622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dafitinib</a:t>
                      </a:r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+ PD-1 </a:t>
                      </a:r>
                      <a:r>
                        <a:rPr lang="fr-FR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1502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line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98302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nd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(48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39362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rd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 (29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70072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th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(19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69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th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0597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 objective </a:t>
                      </a:r>
                      <a:r>
                        <a:rPr lang="fr-FR" sz="9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ponse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3186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(5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83839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(57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99162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 (29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59244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D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 (10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3877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-progression </a:t>
                      </a:r>
                      <a:r>
                        <a:rPr lang="fr-FR" sz="9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s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8651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DNA and tissue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(57)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512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DNA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 (29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31056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fr-FR" sz="9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issue</a:t>
                      </a:r>
                      <a:endParaRPr lang="it-IT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(14)</a:t>
                      </a:r>
                      <a:endParaRPr lang="it-IT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415" marR="32415" marT="16502" marB="16502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4316637"/>
                  </a:ext>
                </a:extLst>
              </a:tr>
            </a:tbl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C12747E3-3C6C-053E-9E1B-2B352F8AE66B}"/>
              </a:ext>
            </a:extLst>
          </p:cNvPr>
          <p:cNvSpPr txBox="1"/>
          <p:nvPr/>
        </p:nvSpPr>
        <p:spPr>
          <a:xfrm>
            <a:off x="0" y="0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71E36A6D-682E-9A95-F1FA-69A6F7B489B8}"/>
              </a:ext>
            </a:extLst>
          </p:cNvPr>
          <p:cNvSpPr txBox="1"/>
          <p:nvPr/>
        </p:nvSpPr>
        <p:spPr>
          <a:xfrm>
            <a:off x="160868" y="7137401"/>
            <a:ext cx="6527800" cy="98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. Patient population, treatment outcomes and post-progression sample availability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: Complete response; PR: Partial response; SD: Stable disease; PD: Progressive disease;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Circulating tumor DNA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22898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200</Words>
  <Application>Microsoft Macintosh PowerPoint</Application>
  <PresentationFormat>A4 (21x29,7 cm)</PresentationFormat>
  <Paragraphs>5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2</cp:revision>
  <dcterms:created xsi:type="dcterms:W3CDTF">2022-12-10T11:29:14Z</dcterms:created>
  <dcterms:modified xsi:type="dcterms:W3CDTF">2023-04-01T16:44:15Z</dcterms:modified>
</cp:coreProperties>
</file>